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9" r:id="rId3"/>
    <p:sldId id="260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2" d="100"/>
          <a:sy n="62" d="100"/>
        </p:scale>
        <p:origin x="1424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B1D72C-3DDB-476A-A76A-40010F522361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F4A12-31A5-4D27-8137-24C7616367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29830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B1D72C-3DDB-476A-A76A-40010F522361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F4A12-31A5-4D27-8137-24C7616367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26069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B1D72C-3DDB-476A-A76A-40010F522361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F4A12-31A5-4D27-8137-24C7616367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57345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B1D72C-3DDB-476A-A76A-40010F522361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F4A12-31A5-4D27-8137-24C7616367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58900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B1D72C-3DDB-476A-A76A-40010F522361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F4A12-31A5-4D27-8137-24C7616367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87122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B1D72C-3DDB-476A-A76A-40010F522361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F4A12-31A5-4D27-8137-24C7616367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43597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B1D72C-3DDB-476A-A76A-40010F522361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F4A12-31A5-4D27-8137-24C7616367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83198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B1D72C-3DDB-476A-A76A-40010F522361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F4A12-31A5-4D27-8137-24C7616367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34743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B1D72C-3DDB-476A-A76A-40010F522361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F4A12-31A5-4D27-8137-24C7616367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53858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B1D72C-3DDB-476A-A76A-40010F522361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F4A12-31A5-4D27-8137-24C7616367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04347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B1D72C-3DDB-476A-A76A-40010F522361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7F4A12-31A5-4D27-8137-24C7616367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67507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B1D72C-3DDB-476A-A76A-40010F522361}" type="datetimeFigureOut">
              <a:rPr kumimoji="1" lang="ja-JP" altLang="en-US" smtClean="0"/>
              <a:t>2022/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7F4A12-31A5-4D27-8137-24C7616367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0363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A5BF310-CB91-47F4-8EA8-9FB274632E7F}"/>
              </a:ext>
            </a:extLst>
          </p:cNvPr>
          <p:cNvSpPr txBox="1"/>
          <p:nvPr/>
        </p:nvSpPr>
        <p:spPr>
          <a:xfrm>
            <a:off x="252239" y="745764"/>
            <a:ext cx="416331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3200" dirty="0">
                <a:latin typeface="Times New Roman" panose="02020603050405020304" pitchFamily="18" charset="0"/>
              </a:rPr>
              <a:t>Supplementary Material</a:t>
            </a:r>
            <a:endParaRPr lang="ja-JP" altLang="en-US" sz="3200" dirty="0">
              <a:latin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1E30D07-0611-4BE1-9BC6-4438EBD33B2D}"/>
              </a:ext>
            </a:extLst>
          </p:cNvPr>
          <p:cNvSpPr txBox="1"/>
          <p:nvPr/>
        </p:nvSpPr>
        <p:spPr>
          <a:xfrm>
            <a:off x="252239" y="2157606"/>
            <a:ext cx="837117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dirty="0">
                <a:latin typeface="Times New Roman" panose="02020603050405020304" pitchFamily="18" charset="0"/>
              </a:rPr>
              <a:t>Title</a:t>
            </a:r>
            <a:r>
              <a:rPr lang="en-US" altLang="ja-JP" sz="2400">
                <a:latin typeface="Times New Roman" panose="02020603050405020304" pitchFamily="18" charset="0"/>
              </a:rPr>
              <a:t>: Use of </a:t>
            </a:r>
            <a:r>
              <a:rPr lang="en-US" altLang="ja-JP" sz="2400" dirty="0">
                <a:latin typeface="Times New Roman" panose="02020603050405020304" pitchFamily="18" charset="0"/>
              </a:rPr>
              <a:t>a baculovirus-mammalian cell expression-system for expression of drug-metabolizing enzymes: optimization of infection with a focus on cytochrome P450 3A4</a:t>
            </a:r>
            <a:endParaRPr lang="ja-JP" altLang="en-US" sz="2400" dirty="0">
              <a:latin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2736D94-15B1-49CE-AA66-AE84F9B313EE}"/>
              </a:ext>
            </a:extLst>
          </p:cNvPr>
          <p:cNvSpPr txBox="1"/>
          <p:nvPr/>
        </p:nvSpPr>
        <p:spPr>
          <a:xfrm>
            <a:off x="252239" y="4676941"/>
            <a:ext cx="811529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</a:rPr>
              <a:t>Authors: Yuu Miyauchi, </a:t>
            </a:r>
            <a:r>
              <a:rPr lang="en-US" altLang="ja-JP" sz="2000" dirty="0" err="1">
                <a:latin typeface="Times New Roman" panose="02020603050405020304" pitchFamily="18" charset="0"/>
              </a:rPr>
              <a:t>Akane</a:t>
            </a:r>
            <a:r>
              <a:rPr lang="en-US" altLang="ja-JP" sz="2000" dirty="0">
                <a:latin typeface="Times New Roman" panose="02020603050405020304" pitchFamily="18" charset="0"/>
              </a:rPr>
              <a:t> Kimura, </a:t>
            </a:r>
            <a:r>
              <a:rPr lang="en-US" altLang="ja-JP" sz="2000" dirty="0" err="1">
                <a:latin typeface="Times New Roman" panose="02020603050405020304" pitchFamily="18" charset="0"/>
              </a:rPr>
              <a:t>Madoka</a:t>
            </a:r>
            <a:r>
              <a:rPr lang="en-US" altLang="ja-JP" sz="2000" dirty="0">
                <a:latin typeface="Times New Roman" panose="02020603050405020304" pitchFamily="18" charset="0"/>
              </a:rPr>
              <a:t> Sawai, Keiko Fujimoto, Yuko </a:t>
            </a:r>
            <a:r>
              <a:rPr lang="en-US" altLang="ja-JP" sz="2000" dirty="0" err="1">
                <a:latin typeface="Times New Roman" panose="02020603050405020304" pitchFamily="18" charset="0"/>
              </a:rPr>
              <a:t>Hirota</a:t>
            </a:r>
            <a:r>
              <a:rPr lang="en-US" altLang="ja-JP" sz="2000" dirty="0">
                <a:latin typeface="Times New Roman" panose="02020603050405020304" pitchFamily="18" charset="0"/>
              </a:rPr>
              <a:t>, Yoshitaka Tanaka, Shinji </a:t>
            </a:r>
            <a:r>
              <a:rPr lang="en-US" altLang="ja-JP" sz="2000" dirty="0" err="1">
                <a:latin typeface="Times New Roman" panose="02020603050405020304" pitchFamily="18" charset="0"/>
              </a:rPr>
              <a:t>Takechi</a:t>
            </a:r>
            <a:r>
              <a:rPr lang="en-US" altLang="ja-JP" sz="2000" dirty="0">
                <a:latin typeface="Times New Roman" panose="02020603050405020304" pitchFamily="18" charset="0"/>
              </a:rPr>
              <a:t>, Peter I. Mackenzie, </a:t>
            </a:r>
          </a:p>
          <a:p>
            <a:r>
              <a:rPr lang="en-US" altLang="ja-JP" sz="2000" dirty="0">
                <a:latin typeface="Times New Roman" panose="02020603050405020304" pitchFamily="18" charset="0"/>
              </a:rPr>
              <a:t>and Yuji Ishii,</a:t>
            </a:r>
            <a:endParaRPr lang="ja-JP" altLang="en-US" sz="2000" dirty="0"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83064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9F247FB3-58FD-40A8-BB59-4C4CAE5F880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37082745"/>
              </p:ext>
            </p:extLst>
          </p:nvPr>
        </p:nvGraphicFramePr>
        <p:xfrm>
          <a:off x="461169" y="2266950"/>
          <a:ext cx="8221662" cy="2324100"/>
        </p:xfrm>
        <a:graphic>
          <a:graphicData uri="http://schemas.openxmlformats.org/drawingml/2006/table">
            <a:tbl>
              <a:tblPr/>
              <a:tblGrid>
                <a:gridCol w="135413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191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5626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90500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upplemental Table </a:t>
                      </a:r>
                      <a:r>
                        <a:rPr lang="en-US" altLang="ja-JP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0025"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rimers for subcloning of drug-metabolizing enzym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onstruc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equenc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EZT-BM_CYP3A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Forwar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'-ATAGGCTAGCCTCGAGTGATGGCTCTCATCCCA-3'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evers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'-GGTTGATTAAGCTTGTCAGGCTCCACTTACGGT-3'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EZT-BM_UGT1A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Forwar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'-ATAGGCTAGCCTCGAGCCATGGCTGTGGAGTCC-3'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evers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'-GGTTGATTAAGCTTGTCAATGGGTCTTGGATTTGT-3'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EZT-BM_UGT2B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Forwar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'-ATAGGCTAGCCTCGAGGGATGTCTGTGAAATGGA-3'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70571">
                <a:tc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evers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'-GGTTGATTAAGCTTGCTAATCATTTTTTCCCTTCTTT-3'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cDNA3.1_CYP3A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Forwar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’-CCG</a:t>
                      </a:r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TCGAG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TGATGGCTCTCATCCCAGAC-3’    (underline: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XhoI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site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421551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evers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’-CGG</a:t>
                      </a:r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GTACC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CAGGCTCCACTTACGGTGC-3’       (underline: KpnI site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5137286"/>
                  </a:ext>
                </a:extLst>
              </a:tr>
              <a:tr h="190500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453247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717ED075-08B4-4300-BD23-A4512B6C7379}"/>
              </a:ext>
            </a:extLst>
          </p:cNvPr>
          <p:cNvGrpSpPr/>
          <p:nvPr/>
        </p:nvGrpSpPr>
        <p:grpSpPr>
          <a:xfrm>
            <a:off x="3523476" y="313612"/>
            <a:ext cx="2097049" cy="1843965"/>
            <a:chOff x="3433592" y="724574"/>
            <a:chExt cx="2097049" cy="1843965"/>
          </a:xfrm>
        </p:grpSpPr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B4E4B883-020A-4A25-9A92-D95322BA4C0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50592" y="724574"/>
              <a:ext cx="1463040" cy="1463040"/>
            </a:xfrm>
            <a:prstGeom prst="rect">
              <a:avLst/>
            </a:prstGeom>
          </p:spPr>
        </p:pic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E088FF85-698E-47EC-B002-324D9DB30017}"/>
                </a:ext>
              </a:extLst>
            </p:cNvPr>
            <p:cNvSpPr txBox="1"/>
            <p:nvPr/>
          </p:nvSpPr>
          <p:spPr>
            <a:xfrm>
              <a:off x="3433592" y="2291540"/>
              <a:ext cx="20970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ea typeface="源ノ角ゴシック Code JP R" panose="020B0500000000000000" pitchFamily="34" charset="-128"/>
                  <a:cs typeface="Arial" panose="020B0604020202020204" pitchFamily="34" charset="0"/>
                </a:rPr>
                <a:t>Not-transfected COS-1 cells</a:t>
              </a:r>
            </a:p>
          </p:txBody>
        </p:sp>
      </p:grp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885E69B7-EAC9-447F-B4A7-9F44E9794D91}"/>
              </a:ext>
            </a:extLst>
          </p:cNvPr>
          <p:cNvGrpSpPr/>
          <p:nvPr/>
        </p:nvGrpSpPr>
        <p:grpSpPr>
          <a:xfrm>
            <a:off x="715458" y="2637894"/>
            <a:ext cx="7713085" cy="1898648"/>
            <a:chOff x="154637" y="3429000"/>
            <a:chExt cx="7713085" cy="1898648"/>
          </a:xfrm>
        </p:grpSpPr>
        <p:pic>
          <p:nvPicPr>
            <p:cNvPr id="2" name="図 1">
              <a:extLst>
                <a:ext uri="{FF2B5EF4-FFF2-40B4-BE49-F238E27FC236}">
                  <a16:creationId xmlns:a16="http://schemas.microsoft.com/office/drawing/2014/main" id="{87D19522-2D0A-404E-A043-501DE0728F4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71444" y="3429000"/>
              <a:ext cx="1463040" cy="1463040"/>
            </a:xfrm>
            <a:prstGeom prst="rect">
              <a:avLst/>
            </a:prstGeom>
          </p:spPr>
        </p:pic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B5FD3197-71B0-4E4D-AADF-F070A79C60A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49190" y="3431559"/>
              <a:ext cx="1463040" cy="1463040"/>
            </a:xfrm>
            <a:prstGeom prst="rect">
              <a:avLst/>
            </a:prstGeom>
          </p:spPr>
        </p:pic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F432CA4F-E0AF-4CE0-85FF-4E5F817F628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26936" y="3429000"/>
              <a:ext cx="1463040" cy="1463040"/>
            </a:xfrm>
            <a:prstGeom prst="rect">
              <a:avLst/>
            </a:prstGeom>
          </p:spPr>
        </p:pic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8E954C7A-245C-456B-B8B6-6231E2FCF64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04682" y="3429000"/>
              <a:ext cx="1463040" cy="1463040"/>
            </a:xfrm>
            <a:prstGeom prst="rect">
              <a:avLst/>
            </a:prstGeom>
          </p:spPr>
        </p:pic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4CB77D02-BD32-49DB-8CFD-983D1E18C876}"/>
                </a:ext>
              </a:extLst>
            </p:cNvPr>
            <p:cNvSpPr txBox="1"/>
            <p:nvPr/>
          </p:nvSpPr>
          <p:spPr>
            <a:xfrm>
              <a:off x="154637" y="5050649"/>
              <a:ext cx="7729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ea typeface="源ノ角ゴシック Code JP R" panose="020B0500000000000000" pitchFamily="34" charset="-128"/>
                  <a:cs typeface="Arial" panose="020B0604020202020204" pitchFamily="34" charset="0"/>
                </a:rPr>
                <a:t>Bacmids</a:t>
              </a: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C327363E-386C-4334-8F19-6665306FFA40}"/>
                </a:ext>
              </a:extLst>
            </p:cNvPr>
            <p:cNvSpPr txBox="1"/>
            <p:nvPr/>
          </p:nvSpPr>
          <p:spPr>
            <a:xfrm>
              <a:off x="1207289" y="5050649"/>
              <a:ext cx="119135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ea typeface="源ノ角ゴシック Code JP R" panose="020B0500000000000000" pitchFamily="34" charset="-128"/>
                  <a:cs typeface="Arial" panose="020B0604020202020204" pitchFamily="34" charset="0"/>
                </a:rPr>
                <a:t>Control (Mock)</a:t>
              </a: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B2E926C5-B013-434C-87F7-A0D757C4B3D1}"/>
                </a:ext>
              </a:extLst>
            </p:cNvPr>
            <p:cNvSpPr txBox="1"/>
            <p:nvPr/>
          </p:nvSpPr>
          <p:spPr>
            <a:xfrm>
              <a:off x="3194226" y="5050649"/>
              <a:ext cx="7729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ea typeface="源ノ角ゴシック Code JP R" panose="020B0500000000000000" pitchFamily="34" charset="-128"/>
                  <a:cs typeface="Arial" panose="020B0604020202020204" pitchFamily="34" charset="0"/>
                </a:rPr>
                <a:t>CYP3A4</a:t>
              </a: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2411504A-55BC-48C0-83AE-8B31647B4C5F}"/>
                </a:ext>
              </a:extLst>
            </p:cNvPr>
            <p:cNvSpPr txBox="1"/>
            <p:nvPr/>
          </p:nvSpPr>
          <p:spPr>
            <a:xfrm>
              <a:off x="4967163" y="5050649"/>
              <a:ext cx="7825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ea typeface="源ノ角ゴシック Code JP R" panose="020B0500000000000000" pitchFamily="34" charset="-128"/>
                  <a:cs typeface="Arial" panose="020B0604020202020204" pitchFamily="34" charset="0"/>
                </a:rPr>
                <a:t>UGT1A1</a:t>
              </a: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F4DC7ECF-7BFB-45F1-8976-0DB2D6C7F218}"/>
                </a:ext>
              </a:extLst>
            </p:cNvPr>
            <p:cNvSpPr txBox="1"/>
            <p:nvPr/>
          </p:nvSpPr>
          <p:spPr>
            <a:xfrm>
              <a:off x="6744909" y="5050649"/>
              <a:ext cx="7825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atin typeface="Arial" panose="020B0604020202020204" pitchFamily="34" charset="0"/>
                  <a:ea typeface="源ノ角ゴシック Code JP R" panose="020B0500000000000000" pitchFamily="34" charset="-128"/>
                  <a:cs typeface="Arial" panose="020B0604020202020204" pitchFamily="34" charset="0"/>
                </a:rPr>
                <a:t>UGT2B7</a:t>
              </a:r>
            </a:p>
          </p:txBody>
        </p:sp>
      </p:grp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412AD1FD-A280-41C0-8014-AD9C518059E1}"/>
              </a:ext>
            </a:extLst>
          </p:cNvPr>
          <p:cNvSpPr txBox="1"/>
          <p:nvPr/>
        </p:nvSpPr>
        <p:spPr>
          <a:xfrm>
            <a:off x="243808" y="4730706"/>
            <a:ext cx="8598844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   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tection of green fluorescent protein (GFP) to confirm generation of recombinant baculovirus in insect Sf9 cells. </a:t>
            </a:r>
            <a:r>
              <a:rPr kumimoji="1"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ZT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BM contains p10 promotor followed by open reading frame of GFP. These components were retained in the recombinant bacmids, a part of baculoviral DNA. Hence, GFP was observed in the Sf9 cells positively transfected and generating recombinant baculovirus. The detections were conducted 4 days after transfection of bacmids.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84968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72</TotalTime>
  <Words>222</Words>
  <Application>Microsoft Office PowerPoint</Application>
  <PresentationFormat>画面に合わせる (4:3)</PresentationFormat>
  <Paragraphs>37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宮内 優</dc:creator>
  <cp:lastModifiedBy>宮内 優</cp:lastModifiedBy>
  <cp:revision>8</cp:revision>
  <dcterms:created xsi:type="dcterms:W3CDTF">2021-11-11T01:20:25Z</dcterms:created>
  <dcterms:modified xsi:type="dcterms:W3CDTF">2022-01-07T08:43:45Z</dcterms:modified>
</cp:coreProperties>
</file>